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4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A6F63854-10F5-53DC-AB13-45355B9BD4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19673" y="3429000"/>
            <a:ext cx="10500049" cy="721146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7 Forest plot of daily calorie intake in relation to refeeding syndrome in acutely ill patients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D58F347A-D27F-0DA2-B679-CA52C8561C2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124075" y="1237862"/>
            <a:ext cx="7943850" cy="1770452"/>
            <a:chOff x="1338" y="929"/>
            <a:chExt cx="5004" cy="966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739C3DDF-CA81-4688-86B3-526807443EF1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338" y="929"/>
              <a:ext cx="5004" cy="9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E7236E63-E2E6-77A6-4B5B-3755C22500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8" y="929"/>
              <a:ext cx="5004" cy="966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ACC4FA77-4EF4-5130-9671-E47C0A3A88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38" y="1122"/>
              <a:ext cx="5004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589A9C97-0324-0FD8-FBBD-F6400D2570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8" y="1049"/>
              <a:ext cx="76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tudy or Sub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B42D4245-7C34-FA25-D1FF-177F4A8D4C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8" y="1156"/>
              <a:ext cx="29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i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25B711ED-A66C-1393-45CA-2060F87CF1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8" y="1253"/>
              <a:ext cx="3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ong 202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A907E184-7CF0-21D3-1541-1EB23FFBED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8" y="1436"/>
              <a:ext cx="511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 (95% CI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AE000572-62B0-E602-072A-076E42FABA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8" y="1544"/>
              <a:ext cx="426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otal event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985568A2-EF6D-313D-0665-2A3A10243F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8" y="1639"/>
              <a:ext cx="187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geneity: Chi² = 0.27, df = 1 (P = 0.61); I² = 0%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D48FEF61-A398-9F68-ED49-9A7AD99151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8" y="1736"/>
              <a:ext cx="147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 for overall effect: Z = 5.95 (P &lt; 0.00001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F5C2CC6C-6918-ACFE-BBF4-F472F7B454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3" y="1049"/>
              <a:ext cx="298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Event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61428050-1B85-406A-1BCD-3F4E1E971D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1" y="1156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4AE9A881-E54D-3F2D-3AF4-95BD63D5D5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1" y="1253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40B7DEC5-BDD1-3757-60E1-6C6E88FAC4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1" y="1544"/>
              <a:ext cx="11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9A92B492-3EB6-66DB-F848-618708C41C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9" y="1049"/>
              <a:ext cx="230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3BDBC895-AFA9-8E77-0023-2B407623A1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7" y="1156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59A5AB4B-548D-282F-636B-B41C70E47E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7" y="1253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6AA5C90E-E612-DF77-8631-23AAD50141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1" y="1436"/>
              <a:ext cx="155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9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F5F67807-673B-2589-BDB2-0F07CFA9C0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4" y="1049"/>
              <a:ext cx="298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Event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08BD94A6-E5E3-273E-85EF-A597D2C0C3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2" y="1156"/>
              <a:ext cx="16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352F2BBC-0492-EDEE-E99C-57934FD7AA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2" y="1253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317D1BBE-AA46-6E9E-AB8B-27BF7DFC3E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2" y="1544"/>
              <a:ext cx="152" cy="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1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77BAB2BB-5D5D-028E-FAB0-48C573F7DA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28" y="1049"/>
              <a:ext cx="22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0BED0EC5-96CE-B8F4-5138-5B04C7AD91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6" y="1156"/>
              <a:ext cx="16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1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971F8755-3E90-1902-DC71-77581D25C4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6" y="1253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DBAC367C-4AFE-E42A-0246-9711EC2E50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0" y="1436"/>
              <a:ext cx="155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517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2943A4F0-D66A-C37D-F6B0-C943BDA26A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6" y="1049"/>
              <a:ext cx="305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FC387D90-A044-5C06-76E2-E90A68B4F1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2" y="1156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6.1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F3450FA3-3E82-0E65-C271-DF26227152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2" y="1253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3.9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EF1D29B8-3A88-E250-18D3-F31EA0EF17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6" y="1436"/>
              <a:ext cx="279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0.0%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391980DF-1869-CA25-AFDC-4C67C7F192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7" y="1049"/>
              <a:ext cx="744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-H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C3663715-117E-07DD-3254-CB111A37AF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3" y="1156"/>
              <a:ext cx="60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1 [0.17, 0.56]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675B17FF-2280-FA8F-FDCA-BC3D0ACA7B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3" y="1253"/>
              <a:ext cx="55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7 [0.24, 0.57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AB6E5E42-D66B-AA69-1E5A-A64E732356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9" y="1436"/>
              <a:ext cx="562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0.35 [0.25, 0.49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5891921A-CE90-7ACE-9C0B-BF7C322076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0" y="953"/>
              <a:ext cx="415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C83EA99D-15BE-2AE6-C139-BB20AB98F5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20" y="953"/>
              <a:ext cx="570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non-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A2423335-3DFE-8209-321A-8142299396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9" y="953"/>
              <a:ext cx="418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Odds Ratio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F696B045-6B46-1D91-090B-050FC94BB8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9" y="953"/>
              <a:ext cx="418" cy="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Odds Ratio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1B88B793-D998-52F8-1F5C-7F5D488063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11" y="1049"/>
              <a:ext cx="745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-H, Fixed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Line 43">
              <a:extLst>
                <a:ext uri="{FF2B5EF4-FFF2-40B4-BE49-F238E27FC236}">
                  <a16:creationId xmlns:a16="http://schemas.microsoft.com/office/drawing/2014/main" id="{475C141C-F6A5-0498-917E-5320F973EB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15" y="1122"/>
              <a:ext cx="0" cy="532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" name="Line 44">
              <a:extLst>
                <a:ext uri="{FF2B5EF4-FFF2-40B4-BE49-F238E27FC236}">
                  <a16:creationId xmlns:a16="http://schemas.microsoft.com/office/drawing/2014/main" id="{3347AE8E-32B3-2998-856B-CC552C2CAD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44" y="1171"/>
              <a:ext cx="250" cy="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1AA5201E-8122-3158-22D8-C16F1CA5A6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5" y="1153"/>
              <a:ext cx="47" cy="47"/>
            </a:xfrm>
            <a:prstGeom prst="rect">
              <a:avLst/>
            </a:prstGeom>
            <a:solidFill>
              <a:srgbClr val="0000C0"/>
            </a:solidFill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" name="Line 46">
              <a:extLst>
                <a:ext uri="{FF2B5EF4-FFF2-40B4-BE49-F238E27FC236}">
                  <a16:creationId xmlns:a16="http://schemas.microsoft.com/office/drawing/2014/main" id="{135D51D1-471B-90DA-9E9B-3858BF733A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20" y="1267"/>
              <a:ext cx="178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4E90811F-9918-6AA2-870A-0D7C6CCFDB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2" y="1236"/>
              <a:ext cx="74" cy="74"/>
            </a:xfrm>
            <a:prstGeom prst="rect">
              <a:avLst/>
            </a:prstGeom>
            <a:solidFill>
              <a:srgbClr val="0000C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1" name="Freeform 48">
              <a:extLst>
                <a:ext uri="{FF2B5EF4-FFF2-40B4-BE49-F238E27FC236}">
                  <a16:creationId xmlns:a16="http://schemas.microsoft.com/office/drawing/2014/main" id="{57CA7B4A-FB7D-8B82-B06F-966E9D2095C1}"/>
                </a:ext>
              </a:extLst>
            </p:cNvPr>
            <p:cNvSpPr>
              <a:spLocks/>
            </p:cNvSpPr>
            <p:nvPr/>
          </p:nvSpPr>
          <p:spPr bwMode="auto">
            <a:xfrm>
              <a:off x="5020" y="1418"/>
              <a:ext cx="145" cy="85"/>
            </a:xfrm>
            <a:custGeom>
              <a:avLst/>
              <a:gdLst>
                <a:gd name="T0" fmla="*/ 240 w 480"/>
                <a:gd name="T1" fmla="*/ 280 h 280"/>
                <a:gd name="T2" fmla="*/ 0 w 480"/>
                <a:gd name="T3" fmla="*/ 140 h 280"/>
                <a:gd name="T4" fmla="*/ 240 w 480"/>
                <a:gd name="T5" fmla="*/ 0 h 280"/>
                <a:gd name="T6" fmla="*/ 480 w 480"/>
                <a:gd name="T7" fmla="*/ 140 h 280"/>
                <a:gd name="T8" fmla="*/ 240 w 48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80" h="280">
                  <a:moveTo>
                    <a:pt x="240" y="280"/>
                  </a:moveTo>
                  <a:lnTo>
                    <a:pt x="0" y="140"/>
                  </a:lnTo>
                  <a:lnTo>
                    <a:pt x="240" y="0"/>
                  </a:lnTo>
                  <a:lnTo>
                    <a:pt x="480" y="140"/>
                  </a:lnTo>
                  <a:lnTo>
                    <a:pt x="240" y="280"/>
                  </a:lnTo>
                  <a:close/>
                </a:path>
              </a:pathLst>
            </a:custGeom>
            <a:solidFill>
              <a:srgbClr val="000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" name="Line 49">
              <a:extLst>
                <a:ext uri="{FF2B5EF4-FFF2-40B4-BE49-F238E27FC236}">
                  <a16:creationId xmlns:a16="http://schemas.microsoft.com/office/drawing/2014/main" id="{E90295AA-88B8-D3F9-641D-DDC7F91968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54" y="1654"/>
              <a:ext cx="192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" name="Line 50">
              <a:extLst>
                <a:ext uri="{FF2B5EF4-FFF2-40B4-BE49-F238E27FC236}">
                  <a16:creationId xmlns:a16="http://schemas.microsoft.com/office/drawing/2014/main" id="{9799CF45-F83B-8E21-BCD3-83B3BCFF5A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54" y="1629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21463E1A-EE2C-6439-4569-72F5BB63CA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54" y="1687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Line 52">
              <a:extLst>
                <a:ext uri="{FF2B5EF4-FFF2-40B4-BE49-F238E27FC236}">
                  <a16:creationId xmlns:a16="http://schemas.microsoft.com/office/drawing/2014/main" id="{2CA07A99-DACB-EDB2-F838-6D5613F73A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34" y="1629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9AE4F9A5-22F4-64D7-8299-44C50CCE4A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84" y="1687"/>
              <a:ext cx="14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Line 54">
              <a:extLst>
                <a:ext uri="{FF2B5EF4-FFF2-40B4-BE49-F238E27FC236}">
                  <a16:creationId xmlns:a16="http://schemas.microsoft.com/office/drawing/2014/main" id="{7171A1FA-B37C-3B31-8F41-086FCF1A2C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15" y="1629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94C9F1FE-2274-A0A6-E4E1-D5F212F4D5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95" y="1687"/>
              <a:ext cx="7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Line 56">
              <a:extLst>
                <a:ext uri="{FF2B5EF4-FFF2-40B4-BE49-F238E27FC236}">
                  <a16:creationId xmlns:a16="http://schemas.microsoft.com/office/drawing/2014/main" id="{CDE006B6-8859-2C19-DE06-5560B5E2E1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95" y="1629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0EE2EBF3-CA16-8ED0-A845-54C9C39791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55" y="1687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Line 58">
              <a:extLst>
                <a:ext uri="{FF2B5EF4-FFF2-40B4-BE49-F238E27FC236}">
                  <a16:creationId xmlns:a16="http://schemas.microsoft.com/office/drawing/2014/main" id="{558C8C32-1536-B29F-000B-E2F54F0200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76" y="1629"/>
              <a:ext cx="0" cy="4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2CC94B0B-73E4-5CF1-D2F9-9E594A8793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6" y="1687"/>
              <a:ext cx="16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01B63A5A-5CC9-BA97-D23F-BD1F341287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2" y="1776"/>
              <a:ext cx="70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A997DD7C-8C3D-825E-DC92-8552CEDFC3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45" y="1776"/>
              <a:ext cx="84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non-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83555292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9</Words>
  <Application>Microsoft Office PowerPoint</Application>
  <PresentationFormat>宽屏</PresentationFormat>
  <Paragraphs>4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轩乐</dc:creator>
  <cp:lastModifiedBy>轩乐 吴</cp:lastModifiedBy>
  <cp:revision>5</cp:revision>
  <dcterms:created xsi:type="dcterms:W3CDTF">2023-08-09T12:44:00Z</dcterms:created>
  <dcterms:modified xsi:type="dcterms:W3CDTF">2026-02-06T15:57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